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pptx" ContentType="application/vnd.openxmlformats-officedocument.presentationml.presentation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B6416-6760-4EA7-9600-3DC1F0DA59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B456A-4794-4970-AF3A-BAFD188CBD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8D5D6-B8A2-45F6-877E-0730F6A6BA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0EEF5-B704-457A-B1CD-0ADD8B626D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F8146-87DB-44CF-8237-C2749F71DE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7C941D-0C28-42C9-ABFE-D4BFB732F3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60586-B93B-4835-9665-53011DAEC1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5E44B-5B5F-4A22-9F99-FE298B4F98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E70B9-3E15-4AAD-A91A-51EC816FFB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FEAE2-FA16-4B85-954B-9B3535EF31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543AD-CB49-4409-A9B1-B2A3DB3B0C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ADAC6-7242-4825-AAFE-8ED52A643D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B39ACE-DCDB-48AC-BAFE-31B8A0CAD82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pptx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5207040"/>
            <a:ext cx="67057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otal RNA was extracted from hepatopancreas of two females (A and B) that were frozen immediately after dissection (lanes 1 and 4) and after 6 h incubation (Lanes 2, 3 and 5,6) as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pecified in the materials section. Samples (15 ug) were resolved 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.2% formaldehyde agarose gel and visualized with Ethidium bromide staining. M(bp)= RNA marker. Position of the 28S and 18S ribosomal RNA is indicated by arrow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600920" y="1649520"/>
            <a:ext cx="3304440" cy="2998800"/>
            <a:chOff x="1600920" y="1649520"/>
            <a:chExt cx="3304440" cy="2998800"/>
          </a:xfrm>
        </p:grpSpPr>
        <p:graphicFrame>
          <p:nvGraphicFramePr>
            <p:cNvPr id="43" name=""/>
            <p:cNvGraphicFramePr/>
            <p:nvPr/>
          </p:nvGraphicFramePr>
          <p:xfrm>
            <a:off x="2241720" y="1828800"/>
            <a:ext cx="2663640" cy="2819520"/>
          </p:xfrm>
          <a:graphic>
            <a:graphicData uri="http://schemas.openxmlformats.org/presentationml/2006/ole">
              <p:oleObj progId="PowerPoint.Show.12" r:id="rId1" spid="">
                <p:embed/>
                <p:pic>
                  <p:nvPicPr>
                    <p:cNvPr id="4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241720" y="1828800"/>
                      <a:ext cx="2663640" cy="2819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5" name=""/>
            <p:cNvSpPr/>
            <p:nvPr/>
          </p:nvSpPr>
          <p:spPr>
            <a:xfrm>
              <a:off x="2668320" y="2133720"/>
              <a:ext cx="189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1      2       3      4       5       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228760" y="1859040"/>
              <a:ext cx="1843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"/>
            <p:cNvGrpSpPr/>
            <p:nvPr/>
          </p:nvGrpSpPr>
          <p:grpSpPr>
            <a:xfrm>
              <a:off x="1600920" y="1649520"/>
              <a:ext cx="709560" cy="2132280"/>
              <a:chOff x="1600920" y="1649520"/>
              <a:chExt cx="709560" cy="2132280"/>
            </a:xfrm>
          </p:grpSpPr>
          <p:sp>
            <p:nvSpPr>
              <p:cNvPr id="48" name=""/>
              <p:cNvSpPr/>
              <p:nvPr/>
            </p:nvSpPr>
            <p:spPr>
              <a:xfrm>
                <a:off x="1600920" y="1649520"/>
                <a:ext cx="709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</a:rPr>
                  <a:t>M (bp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038320" y="365760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038320" y="320040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038320" y="274320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038320" y="251460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038320" y="228600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038320" y="216216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038320" y="2095560"/>
                <a:ext cx="152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6" name=""/>
              <p:cNvGrpSpPr/>
              <p:nvPr/>
            </p:nvGrpSpPr>
            <p:grpSpPr>
              <a:xfrm>
                <a:off x="1601640" y="1941480"/>
                <a:ext cx="485640" cy="1840320"/>
                <a:chOff x="1601640" y="1941480"/>
                <a:chExt cx="485640" cy="1840320"/>
              </a:xfrm>
            </p:grpSpPr>
            <p:sp>
              <p:nvSpPr>
                <p:cNvPr id="57" name=""/>
                <p:cNvSpPr/>
                <p:nvPr/>
              </p:nvSpPr>
              <p:spPr>
                <a:xfrm>
                  <a:off x="1677960" y="3505320"/>
                  <a:ext cx="409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5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1601640" y="3057480"/>
                  <a:ext cx="485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1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1601640" y="2610000"/>
                  <a:ext cx="485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2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1601640" y="2362320"/>
                  <a:ext cx="485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3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1601640" y="2152800"/>
                  <a:ext cx="485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5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1601640" y="2038320"/>
                  <a:ext cx="485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7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1601640" y="1941480"/>
                  <a:ext cx="485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9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4" name=""/>
            <p:cNvSpPr/>
            <p:nvPr/>
          </p:nvSpPr>
          <p:spPr>
            <a:xfrm>
              <a:off x="2743200" y="2133720"/>
              <a:ext cx="7621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657600" y="2133720"/>
              <a:ext cx="7621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908080" y="18651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906720" y="186516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1076040" y="1166760"/>
            <a:ext cx="363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NA stability during 6 hr incub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>
            <a:off x="4876560" y="2590920"/>
            <a:ext cx="2286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4876560" y="2819520"/>
            <a:ext cx="2286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106960" y="2438280"/>
            <a:ext cx="85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8S r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090760" y="2703600"/>
            <a:ext cx="85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S r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03T21:41:37Z</dcterms:created>
  <dc:creator>zmora</dc:creator>
  <dc:description/>
  <dc:language>en-US</dc:language>
  <cp:lastModifiedBy>sook chung</cp:lastModifiedBy>
  <dcterms:modified xsi:type="dcterms:W3CDTF">2009-06-30T21:21:56Z</dcterms:modified>
  <cp:revision>63</cp:revision>
  <dc:subject/>
  <dc:title>Standard Curve of Neuropepides / MIH antibody</dc:title>
</cp:coreProperties>
</file>